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9826"/>
    <p:restoredTop sz="94719"/>
  </p:normalViewPr>
  <p:slideViewPr>
    <p:cSldViewPr snapToGrid="0" snapToObjects="1">
      <p:cViewPr varScale="1">
        <p:scale>
          <a:sx n="98" d="100"/>
          <a:sy n="98" d="100"/>
        </p:scale>
        <p:origin x="200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16C05C-1655-0345-9229-97D9AF2687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B61ECF9-6D30-7940-A2F8-7F4534EB1C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A7D050-C988-D545-A099-C7E12C52F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94E71B-A1E2-364F-B7CF-8798085FE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BAB6F4-3EA3-EF4F-A801-DDCC95D67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671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E3F19F-2998-0A40-874A-82C46985F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5B55CE-AA6C-704F-A4A8-9E461EA691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5BFD89-024A-4640-A99A-A89BCA8582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4826B1-4149-0447-A8ED-7C98DAE01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971E56-4BA8-B446-AFD9-46CC6E4F8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592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9B5078-8CC1-9443-BF6F-C216E91CC0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12AF31-DCA6-3E4A-95FE-3D51E1C426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D6E5C-5466-414E-B8A1-557A3ED92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27EF95-C09E-2342-9CBB-73357598A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D79A61-A832-E240-A461-A93AF3F01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152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529C77-A611-AE49-8C6A-1283514B2E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C6EBEE-6976-A442-AEA3-7058393CF2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639332-5BBD-C046-9B71-9C3DF4F50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E5D21B-2336-4747-B459-4D86208CD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71DB15-13C3-C242-BD35-547D5BA53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26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C022CF-309E-C142-BAC2-3A9310AAE7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D2CDDC-3B60-CE46-8FDB-077C9E462B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B19DB1-3525-234B-B81C-09BF5C95F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0BC92C-8FD0-104B-B2F1-68B8D85854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4AEA76-20CF-8449-B0E8-F31DEEEEE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1022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6F281-05A1-4441-9D46-41631D3630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044434-8921-EB4E-A186-660E1E9A13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4AF9BF-5B25-A94F-A9CB-E4C264AE7C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EC9E00-DCE5-B541-9D39-217ABD7F4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6507C2-285F-8F44-9C59-D982C3C75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BF9C7B-560E-E541-8F97-383724766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756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A224E4-5A66-3C48-A75F-7CD549089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704037-A169-794D-B1B7-BD09519A82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B8A5F8-B342-1D4E-9EF3-1C13E02A4F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DB698F8-5073-9D4C-8B43-FD63169548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691BA8-2D0C-5549-A53A-8735049542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407E53-2324-5D48-BFBF-7D71DA571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C07D617-28DC-0149-9F60-83F9A624F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0508D5D-5601-7441-B240-543EB8A40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923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94ADB0-5626-264E-8ADC-FCF0C7C5C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C667B39-B423-6540-ADBA-C6423CE57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EA19DE-16AC-4A41-8448-DE327AD06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48EF380-6FB3-AE4C-BC19-AA48B210EB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899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F7192C-08C0-6749-868C-124A6578F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AED67F-AE01-5045-9FCA-CCCD05EF9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F05B70-7F79-E944-A47B-E3F0F2D3D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113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3DAB74-3A62-844F-8AFB-8732D188AD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0C77D9-79BD-C244-8FD7-90C8302A26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8BF421-72C7-014E-A26F-4E1E28A29C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7A2C5-7041-6D46-B60B-B3FFB46E5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8984B3-24F1-2143-9DD8-0896C0BEF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AA7562-B8A6-A248-832E-35FB5B72F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489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953737-55AA-4246-8F55-BFB3B201F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045AF9-A00F-8740-9E9D-37F18D8DF9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9F5356-BAEF-544F-81F8-6FD4E760E5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276D09-9CBB-324C-9589-F16AFC910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A280A4-1459-1D46-B695-7577028C5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32E6F6-EBB6-F54B-8631-E6B4A5A88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512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863B5A4-0B89-3846-A2A2-322D486B6F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A911EC-F582-4B40-9259-CCAA5B460B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B56835-7695-254E-9D39-340EE75A0B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83DCA-1571-6843-85C8-A24F0379C0D8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A09862-338B-8340-8831-14F356E9C0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1498FD-A278-394B-8D06-8B9739B816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E89C1-22FC-FF4D-B9FE-7DD0EC82E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312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5C36D19-6718-CE43-91DE-3334B83E3C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7562" y="968287"/>
            <a:ext cx="5807765" cy="386328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E09B50A-AEF7-8E40-AF21-E2B9F416E4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57562" y="4815808"/>
            <a:ext cx="5807765" cy="184850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E7CADB0-C0A7-7249-9EE7-74445FCABD2F}"/>
              </a:ext>
            </a:extLst>
          </p:cNvPr>
          <p:cNvSpPr txBox="1"/>
          <p:nvPr/>
        </p:nvSpPr>
        <p:spPr>
          <a:xfrm>
            <a:off x="0" y="-37344"/>
            <a:ext cx="5672963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 </a:t>
            </a:r>
            <a:endParaRPr lang="en-US" dirty="0"/>
          </a:p>
          <a:p>
            <a:r>
              <a:rPr lang="en-US" b="1" dirty="0"/>
              <a:t>Figure S6A: </a:t>
            </a:r>
          </a:p>
          <a:p>
            <a:r>
              <a:rPr lang="en-US" dirty="0"/>
              <a:t>The fractions of GRP78 peptides with native deamidation </a:t>
            </a:r>
          </a:p>
          <a:p>
            <a:r>
              <a:rPr lang="en-US" dirty="0"/>
              <a:t>modification (i.e. without </a:t>
            </a:r>
            <a:r>
              <a:rPr lang="en-US" dirty="0" err="1"/>
              <a:t>PNGase</a:t>
            </a:r>
            <a:r>
              <a:rPr lang="en-US" dirty="0"/>
              <a:t> F treatment) in different</a:t>
            </a:r>
          </a:p>
          <a:p>
            <a:r>
              <a:rPr lang="en-US" dirty="0"/>
              <a:t>rGRP78 preparations.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41382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E7CADB0-C0A7-7249-9EE7-74445FCABD2F}"/>
              </a:ext>
            </a:extLst>
          </p:cNvPr>
          <p:cNvSpPr txBox="1"/>
          <p:nvPr/>
        </p:nvSpPr>
        <p:spPr>
          <a:xfrm>
            <a:off x="0" y="-37344"/>
            <a:ext cx="1098063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6B: </a:t>
            </a:r>
          </a:p>
          <a:p>
            <a:r>
              <a:rPr lang="en-US" dirty="0"/>
              <a:t>Comparisons between native deamidation and </a:t>
            </a:r>
            <a:r>
              <a:rPr lang="en-US" dirty="0" err="1"/>
              <a:t>PNGase</a:t>
            </a:r>
            <a:r>
              <a:rPr lang="en-US" dirty="0"/>
              <a:t> F-mediated deamidation (glycosylation modification) levels </a:t>
            </a:r>
          </a:p>
          <a:p>
            <a:r>
              <a:rPr lang="en-US" dirty="0"/>
              <a:t>among different samples</a:t>
            </a:r>
          </a:p>
          <a:p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2D73C40-43E0-D54A-B2F5-AC999EBA2E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5244"/>
          <a:stretch/>
        </p:blipFill>
        <p:spPr>
          <a:xfrm>
            <a:off x="222956" y="1993981"/>
            <a:ext cx="5609914" cy="324062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3005498-C4A4-204A-B6EF-075513CD95F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675" b="25244"/>
          <a:stretch/>
        </p:blipFill>
        <p:spPr>
          <a:xfrm>
            <a:off x="6096000" y="1993981"/>
            <a:ext cx="5459896" cy="324062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ACC2528-9F1C-D74C-AD4D-AC92BDE9C6C3}"/>
              </a:ext>
            </a:extLst>
          </p:cNvPr>
          <p:cNvSpPr txBox="1"/>
          <p:nvPr/>
        </p:nvSpPr>
        <p:spPr>
          <a:xfrm>
            <a:off x="1781876" y="1567368"/>
            <a:ext cx="20569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ative deamidation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4B18399-3D07-EA47-AE17-EF4AA9EBBD92}"/>
              </a:ext>
            </a:extLst>
          </p:cNvPr>
          <p:cNvSpPr txBox="1"/>
          <p:nvPr/>
        </p:nvSpPr>
        <p:spPr>
          <a:xfrm>
            <a:off x="7130380" y="1580621"/>
            <a:ext cx="3279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NGase</a:t>
            </a:r>
            <a:r>
              <a:rPr lang="en-US" dirty="0"/>
              <a:t> F-mediated deamidat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5C31A1B-A176-3044-AA0A-A9A88F35AB58}"/>
              </a:ext>
            </a:extLst>
          </p:cNvPr>
          <p:cNvSpPr txBox="1"/>
          <p:nvPr/>
        </p:nvSpPr>
        <p:spPr>
          <a:xfrm rot="18688822">
            <a:off x="195118" y="5485987"/>
            <a:ext cx="88197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lot#110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609B8F6-13D3-2141-A41C-79EEF8BF276E}"/>
              </a:ext>
            </a:extLst>
          </p:cNvPr>
          <p:cNvSpPr txBox="1"/>
          <p:nvPr/>
        </p:nvSpPr>
        <p:spPr>
          <a:xfrm rot="18688822">
            <a:off x="818623" y="5598275"/>
            <a:ext cx="118173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lot#120914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BD3C507-0007-F940-84C0-678BCDDD1A36}"/>
              </a:ext>
            </a:extLst>
          </p:cNvPr>
          <p:cNvSpPr txBox="1"/>
          <p:nvPr/>
        </p:nvSpPr>
        <p:spPr>
          <a:xfrm rot="18688822">
            <a:off x="1673999" y="5559244"/>
            <a:ext cx="107753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lot#13031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FE0CF4-24B4-C14B-8353-AF5477FF3C8D}"/>
              </a:ext>
            </a:extLst>
          </p:cNvPr>
          <p:cNvSpPr txBox="1"/>
          <p:nvPr/>
        </p:nvSpPr>
        <p:spPr>
          <a:xfrm rot="18688822">
            <a:off x="2695903" y="5559244"/>
            <a:ext cx="107753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lot#14092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BF2520A-4942-464C-84FB-76A6B9333915}"/>
              </a:ext>
            </a:extLst>
          </p:cNvPr>
          <p:cNvSpPr txBox="1"/>
          <p:nvPr/>
        </p:nvSpPr>
        <p:spPr>
          <a:xfrm rot="18688822">
            <a:off x="3695060" y="5495594"/>
            <a:ext cx="90762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in-house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BD2E39D-C355-674D-9CDE-6C79236F445A}"/>
              </a:ext>
            </a:extLst>
          </p:cNvPr>
          <p:cNvSpPr txBox="1"/>
          <p:nvPr/>
        </p:nvSpPr>
        <p:spPr>
          <a:xfrm rot="18688822">
            <a:off x="5897089" y="5485987"/>
            <a:ext cx="88197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lot#110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9FAA935-800C-0D41-BC6C-C42A919E2B42}"/>
              </a:ext>
            </a:extLst>
          </p:cNvPr>
          <p:cNvSpPr txBox="1"/>
          <p:nvPr/>
        </p:nvSpPr>
        <p:spPr>
          <a:xfrm rot="18688822">
            <a:off x="6636969" y="5598275"/>
            <a:ext cx="118173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lot#120914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EB57FE-4053-CF4F-9F0B-ED4CC0E1BA34}"/>
              </a:ext>
            </a:extLst>
          </p:cNvPr>
          <p:cNvSpPr txBox="1"/>
          <p:nvPr/>
        </p:nvSpPr>
        <p:spPr>
          <a:xfrm rot="18688822">
            <a:off x="7608724" y="5559244"/>
            <a:ext cx="107753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lot#13031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A60E75A-CD78-2E49-81CD-B6DF9597D1D1}"/>
              </a:ext>
            </a:extLst>
          </p:cNvPr>
          <p:cNvSpPr txBox="1"/>
          <p:nvPr/>
        </p:nvSpPr>
        <p:spPr>
          <a:xfrm rot="18688822">
            <a:off x="8597377" y="5559244"/>
            <a:ext cx="107753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lot#14092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39DB6C1-30AE-0B49-B00B-28ADB625EAF9}"/>
              </a:ext>
            </a:extLst>
          </p:cNvPr>
          <p:cNvSpPr txBox="1"/>
          <p:nvPr/>
        </p:nvSpPr>
        <p:spPr>
          <a:xfrm rot="18688822">
            <a:off x="9634801" y="5479381"/>
            <a:ext cx="86433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in-house</a:t>
            </a:r>
          </a:p>
        </p:txBody>
      </p:sp>
    </p:spTree>
    <p:extLst>
      <p:ext uri="{BB962C8B-B14F-4D97-AF65-F5344CB8AC3E}">
        <p14:creationId xmlns:p14="http://schemas.microsoft.com/office/powerpoint/2010/main" val="3837221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78</Words>
  <Application>Microsoft Macintosh PowerPoint</Application>
  <PresentationFormat>Widescreen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n Nguyen, Thi Kim</dc:creator>
  <cp:lastModifiedBy>Tran Nguyen, Thi Kim</cp:lastModifiedBy>
  <cp:revision>7</cp:revision>
  <cp:lastPrinted>2020-09-09T15:09:14Z</cp:lastPrinted>
  <dcterms:created xsi:type="dcterms:W3CDTF">2018-08-24T18:13:58Z</dcterms:created>
  <dcterms:modified xsi:type="dcterms:W3CDTF">2020-10-02T21:51:43Z</dcterms:modified>
</cp:coreProperties>
</file>